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276" autoAdjust="0"/>
    <p:restoredTop sz="96494"/>
  </p:normalViewPr>
  <p:slideViewPr>
    <p:cSldViewPr snapToGrid="0">
      <p:cViewPr>
        <p:scale>
          <a:sx n="157" d="100"/>
          <a:sy n="157" d="100"/>
        </p:scale>
        <p:origin x="122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3DD8E2-B3AE-3147-B0CC-5E5F2EB77F73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1241425"/>
            <a:ext cx="23193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4A4001-4039-5548-B4DA-4ABA9C0DC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77509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4A4001-4039-5548-B4DA-4ABA9C0DC56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30987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987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1899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4903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9390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048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468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5140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491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8051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860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72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4FE71-94B3-4F50-BEF3-BD5D26272801}" type="datetimeFigureOut">
              <a:rPr kumimoji="1" lang="ja-JP" altLang="en-US" smtClean="0"/>
              <a:t>2025/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FD90B7-608A-463B-A378-DEE755D942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469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オブジェクト 26">
            <a:extLst>
              <a:ext uri="{FF2B5EF4-FFF2-40B4-BE49-F238E27FC236}">
                <a16:creationId xmlns:a16="http://schemas.microsoft.com/office/drawing/2014/main" id="{7F2BB8F0-6521-0F4B-B035-F21B3D5B3D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8812984"/>
              </p:ext>
            </p:extLst>
          </p:nvPr>
        </p:nvGraphicFramePr>
        <p:xfrm>
          <a:off x="555873" y="3085858"/>
          <a:ext cx="1824037" cy="21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6" name="Prism 9" r:id="rId4" imgW="1824808" imgH="2194058" progId="Prism9.Document">
                  <p:embed/>
                </p:oleObj>
              </mc:Choice>
              <mc:Fallback>
                <p:oleObj name="Prism 9" r:id="rId4" imgW="1824808" imgH="2194058" progId="Prism9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EF823FA3-26E8-9A51-A193-B876B2FB6B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5873" y="3085858"/>
                        <a:ext cx="1824037" cy="21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オブジェクト 31">
            <a:extLst>
              <a:ext uri="{FF2B5EF4-FFF2-40B4-BE49-F238E27FC236}">
                <a16:creationId xmlns:a16="http://schemas.microsoft.com/office/drawing/2014/main" id="{D27C15CA-69C6-CB41-BE64-F1F035DD6F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8459702"/>
              </p:ext>
            </p:extLst>
          </p:nvPr>
        </p:nvGraphicFramePr>
        <p:xfrm>
          <a:off x="4465241" y="461454"/>
          <a:ext cx="1824037" cy="21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7" name="Prism 9" r:id="rId6" imgW="1824808" imgH="2194058" progId="Prism9.Document">
                  <p:embed/>
                </p:oleObj>
              </mc:Choice>
              <mc:Fallback>
                <p:oleObj name="Prism 9" r:id="rId6" imgW="1824808" imgH="2194058" progId="Prism9.Document">
                  <p:embed/>
                  <p:pic>
                    <p:nvPicPr>
                      <p:cNvPr id="14" name="オブジェクト 13">
                        <a:extLst>
                          <a:ext uri="{FF2B5EF4-FFF2-40B4-BE49-F238E27FC236}">
                            <a16:creationId xmlns:a16="http://schemas.microsoft.com/office/drawing/2014/main" id="{8471A97C-4A7D-0BBF-6A0D-E939DDF418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65241" y="461454"/>
                        <a:ext cx="1824037" cy="21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オブジェクト 29">
            <a:extLst>
              <a:ext uri="{FF2B5EF4-FFF2-40B4-BE49-F238E27FC236}">
                <a16:creationId xmlns:a16="http://schemas.microsoft.com/office/drawing/2014/main" id="{5E65E070-41B8-0042-941A-B7A07BD5D0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3646826"/>
              </p:ext>
            </p:extLst>
          </p:nvPr>
        </p:nvGraphicFramePr>
        <p:xfrm>
          <a:off x="2499793" y="465070"/>
          <a:ext cx="1824037" cy="21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8" name="Prism 9" r:id="rId8" imgW="1824808" imgH="2194058" progId="Prism9.Document">
                  <p:embed/>
                </p:oleObj>
              </mc:Choice>
              <mc:Fallback>
                <p:oleObj name="Prism 9" r:id="rId8" imgW="1824808" imgH="2194058" progId="Prism9.Document">
                  <p:embed/>
                  <p:pic>
                    <p:nvPicPr>
                      <p:cNvPr id="16" name="オブジェクト 15">
                        <a:extLst>
                          <a:ext uri="{FF2B5EF4-FFF2-40B4-BE49-F238E27FC236}">
                            <a16:creationId xmlns:a16="http://schemas.microsoft.com/office/drawing/2014/main" id="{D0456E41-79BB-D50E-F434-9BAB640E80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499793" y="465070"/>
                        <a:ext cx="1824037" cy="21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オブジェクト 28">
            <a:extLst>
              <a:ext uri="{FF2B5EF4-FFF2-40B4-BE49-F238E27FC236}">
                <a16:creationId xmlns:a16="http://schemas.microsoft.com/office/drawing/2014/main" id="{9E07ECEB-A02F-244C-8C3F-FAF3DBADF1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1060804"/>
              </p:ext>
            </p:extLst>
          </p:nvPr>
        </p:nvGraphicFramePr>
        <p:xfrm>
          <a:off x="534345" y="467623"/>
          <a:ext cx="1824037" cy="21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9" name="Prism 9" r:id="rId10" imgW="1824808" imgH="2194058" progId="Prism9.Document">
                  <p:embed/>
                </p:oleObj>
              </mc:Choice>
              <mc:Fallback>
                <p:oleObj name="Prism 9" r:id="rId10" imgW="1824808" imgH="2194058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E4D8633D-9F30-F4E7-CF52-857FAE468B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34345" y="467623"/>
                        <a:ext cx="1824037" cy="21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3F8C7E4-7A8E-3748-8A01-968010B2CF3B}"/>
              </a:ext>
            </a:extLst>
          </p:cNvPr>
          <p:cNvSpPr txBox="1"/>
          <p:nvPr/>
        </p:nvSpPr>
        <p:spPr>
          <a:xfrm>
            <a:off x="1094097" y="2540134"/>
            <a:ext cx="57740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4CE03B1-4BBD-B246-B813-C98B393CD8DD}"/>
              </a:ext>
            </a:extLst>
          </p:cNvPr>
          <p:cNvSpPr txBox="1"/>
          <p:nvPr/>
        </p:nvSpPr>
        <p:spPr>
          <a:xfrm>
            <a:off x="1612629" y="2540134"/>
            <a:ext cx="57740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5A97910E-B151-3B49-811D-E90E144F9AEA}"/>
              </a:ext>
            </a:extLst>
          </p:cNvPr>
          <p:cNvSpPr txBox="1"/>
          <p:nvPr/>
        </p:nvSpPr>
        <p:spPr>
          <a:xfrm>
            <a:off x="3062296" y="2540134"/>
            <a:ext cx="57740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46624C1-2896-234C-815E-A5E7E99AD35C}"/>
              </a:ext>
            </a:extLst>
          </p:cNvPr>
          <p:cNvSpPr txBox="1"/>
          <p:nvPr/>
        </p:nvSpPr>
        <p:spPr>
          <a:xfrm>
            <a:off x="3580827" y="2540134"/>
            <a:ext cx="57740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0EA71A18-6482-204D-BEBB-44EA587FB2E3}"/>
              </a:ext>
            </a:extLst>
          </p:cNvPr>
          <p:cNvSpPr txBox="1"/>
          <p:nvPr/>
        </p:nvSpPr>
        <p:spPr>
          <a:xfrm>
            <a:off x="5031395" y="2540134"/>
            <a:ext cx="57740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A3E2F759-15B9-8148-90F6-BE83C57815BA}"/>
              </a:ext>
            </a:extLst>
          </p:cNvPr>
          <p:cNvSpPr txBox="1"/>
          <p:nvPr/>
        </p:nvSpPr>
        <p:spPr>
          <a:xfrm>
            <a:off x="5559258" y="2540134"/>
            <a:ext cx="57740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51AAF3BE-C0AF-6D43-B20D-96F344A5F364}"/>
              </a:ext>
            </a:extLst>
          </p:cNvPr>
          <p:cNvSpPr txBox="1"/>
          <p:nvPr/>
        </p:nvSpPr>
        <p:spPr>
          <a:xfrm>
            <a:off x="1122091" y="5158688"/>
            <a:ext cx="57740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51670B22-460B-FF43-AC7E-D1F7090F6016}"/>
              </a:ext>
            </a:extLst>
          </p:cNvPr>
          <p:cNvSpPr txBox="1"/>
          <p:nvPr/>
        </p:nvSpPr>
        <p:spPr>
          <a:xfrm>
            <a:off x="1640623" y="5158688"/>
            <a:ext cx="57740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7CA2B157-34C9-9C42-A17F-7F7949C1ADAC}"/>
              </a:ext>
            </a:extLst>
          </p:cNvPr>
          <p:cNvSpPr txBox="1"/>
          <p:nvPr/>
        </p:nvSpPr>
        <p:spPr>
          <a:xfrm rot="16200000">
            <a:off x="-300149" y="1427615"/>
            <a:ext cx="1667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D3-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ositive cells/mm</a:t>
            </a:r>
            <a:r>
              <a:rPr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en-US" altLang="ja-JP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6AA39F5E-1CC6-7C4A-98FB-A50FD3EBA375}"/>
              </a:ext>
            </a:extLst>
          </p:cNvPr>
          <p:cNvSpPr txBox="1"/>
          <p:nvPr/>
        </p:nvSpPr>
        <p:spPr>
          <a:xfrm rot="16200000">
            <a:off x="1670069" y="1427615"/>
            <a:ext cx="1667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D8-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ositive cells/mm</a:t>
            </a:r>
            <a:r>
              <a:rPr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en-US" altLang="ja-JP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D3BF6EAB-D3DD-BD4B-94AE-0CC714767B3C}"/>
              </a:ext>
            </a:extLst>
          </p:cNvPr>
          <p:cNvSpPr txBox="1"/>
          <p:nvPr/>
        </p:nvSpPr>
        <p:spPr>
          <a:xfrm rot="16200000">
            <a:off x="3621853" y="1427611"/>
            <a:ext cx="17043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ba1--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ositive cells/mm</a:t>
            </a:r>
            <a:r>
              <a:rPr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en-US" altLang="ja-JP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7168A5E9-8569-4E42-B5B1-EC7D5AADE4BD}"/>
              </a:ext>
            </a:extLst>
          </p:cNvPr>
          <p:cNvSpPr txBox="1"/>
          <p:nvPr/>
        </p:nvSpPr>
        <p:spPr>
          <a:xfrm rot="16200000">
            <a:off x="-378697" y="4052334"/>
            <a:ext cx="18245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D163-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ositive cells/mm</a:t>
            </a:r>
            <a:r>
              <a:rPr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en-US" altLang="ja-JP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79450750-AA6A-6240-938E-8DA2B84C9CF4}"/>
              </a:ext>
            </a:extLst>
          </p:cNvPr>
          <p:cNvSpPr txBox="1"/>
          <p:nvPr/>
        </p:nvSpPr>
        <p:spPr>
          <a:xfrm>
            <a:off x="1206047" y="607316"/>
            <a:ext cx="8691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 &lt;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0.000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098A9CF5-6486-6B4E-B17B-F57AB05E8CDE}"/>
              </a:ext>
            </a:extLst>
          </p:cNvPr>
          <p:cNvSpPr txBox="1"/>
          <p:nvPr/>
        </p:nvSpPr>
        <p:spPr>
          <a:xfrm>
            <a:off x="3176561" y="610209"/>
            <a:ext cx="8691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&lt; 0.000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516D1558-568C-5848-9F54-15B2E862B0D6}"/>
              </a:ext>
            </a:extLst>
          </p:cNvPr>
          <p:cNvSpPr txBox="1"/>
          <p:nvPr/>
        </p:nvSpPr>
        <p:spPr>
          <a:xfrm>
            <a:off x="5197951" y="607316"/>
            <a:ext cx="8691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&lt; 0.000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C2633CCC-247F-7941-8CB9-C595AC50054F}"/>
              </a:ext>
            </a:extLst>
          </p:cNvPr>
          <p:cNvSpPr txBox="1"/>
          <p:nvPr/>
        </p:nvSpPr>
        <p:spPr>
          <a:xfrm>
            <a:off x="1206047" y="3227309"/>
            <a:ext cx="8691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&lt; 0.000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D2ADA5F1-CD28-4448-9008-DE37517596D3}"/>
              </a:ext>
            </a:extLst>
          </p:cNvPr>
          <p:cNvSpPr txBox="1"/>
          <p:nvPr/>
        </p:nvSpPr>
        <p:spPr>
          <a:xfrm>
            <a:off x="405203" y="240367"/>
            <a:ext cx="349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BF3E648D-8002-CB4E-AE0A-911F65360677}"/>
              </a:ext>
            </a:extLst>
          </p:cNvPr>
          <p:cNvSpPr txBox="1"/>
          <p:nvPr/>
        </p:nvSpPr>
        <p:spPr>
          <a:xfrm>
            <a:off x="2379585" y="237571"/>
            <a:ext cx="349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D1D209CC-F890-5440-8F6E-5EC9CC9A3BDB}"/>
              </a:ext>
            </a:extLst>
          </p:cNvPr>
          <p:cNvSpPr txBox="1"/>
          <p:nvPr/>
        </p:nvSpPr>
        <p:spPr>
          <a:xfrm>
            <a:off x="4355639" y="237571"/>
            <a:ext cx="349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7B9CEEA3-C109-9B48-B958-C563415C2CFA}"/>
              </a:ext>
            </a:extLst>
          </p:cNvPr>
          <p:cNvSpPr txBox="1"/>
          <p:nvPr/>
        </p:nvSpPr>
        <p:spPr>
          <a:xfrm>
            <a:off x="405203" y="2847897"/>
            <a:ext cx="349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AEEA24BC-E34A-DC4A-A87B-2481A1300EB5}"/>
              </a:ext>
            </a:extLst>
          </p:cNvPr>
          <p:cNvSpPr/>
          <p:nvPr/>
        </p:nvSpPr>
        <p:spPr>
          <a:xfrm>
            <a:off x="278388" y="5888161"/>
            <a:ext cx="6399469" cy="7741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Arial" panose="020B0604020202020204" pitchFamily="34" charset="0"/>
              </a:rPr>
              <a:t>Supplementary Figure 1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Arial" panose="020B0604020202020204" pitchFamily="34" charset="0"/>
              </a:rPr>
              <a:t>Immune cell densities between Foxp3-low and -high groups. Horizontal lines indicate medians and 95% confidence intervals. (A) CD3. (B) CD8. (C) Iba1. (D) CD163. </a:t>
            </a:r>
            <a:endParaRPr lang="ja-JP" altLang="ja-JP" sz="1200" kern="100">
              <a:latin typeface="Century" panose="02040604050505020304" pitchFamily="18" charset="0"/>
              <a:ea typeface="ＭＳ 明朝" panose="020206090402050803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408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18</TotalTime>
  <Words>95</Words>
  <Application>Microsoft Macintosh PowerPoint</Application>
  <PresentationFormat>A4 210 x 297 mm</PresentationFormat>
  <Paragraphs>30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1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rism 9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菰原 義弘</dc:creator>
  <cp:lastModifiedBy>山田倫</cp:lastModifiedBy>
  <cp:revision>152</cp:revision>
  <cp:lastPrinted>2023-04-06T08:50:40Z</cp:lastPrinted>
  <dcterms:created xsi:type="dcterms:W3CDTF">2023-01-21T01:53:03Z</dcterms:created>
  <dcterms:modified xsi:type="dcterms:W3CDTF">2025-02-13T14:46:42Z</dcterms:modified>
</cp:coreProperties>
</file>